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59" r:id="rId2"/>
    <p:sldId id="261" r:id="rId3"/>
    <p:sldId id="262" r:id="rId4"/>
    <p:sldId id="260" r:id="rId5"/>
    <p:sldId id="257" r:id="rId6"/>
    <p:sldId id="26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1194" autoAdjust="0"/>
  </p:normalViewPr>
  <p:slideViewPr>
    <p:cSldViewPr snapToGrid="0">
      <p:cViewPr>
        <p:scale>
          <a:sx n="50" d="100"/>
          <a:sy n="50" d="100"/>
        </p:scale>
        <p:origin x="468" y="-1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E497ED-6189-46D1-8BDB-09D3271CFA00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2A9EB1-465D-44E5-9803-6C7C7EBA95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871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2A9EB1-465D-44E5-9803-6C7C7EBA95E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844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535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165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101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658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170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98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924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692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4465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017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580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90688-4F02-4C4B-8AC1-4CDD4660DF3F}" type="datetimeFigureOut">
              <a:rPr lang="zh-CN" altLang="en-US" smtClean="0"/>
              <a:t>2020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5881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92518" y="110126"/>
            <a:ext cx="6218144" cy="9213755"/>
            <a:chOff x="482459" y="230048"/>
            <a:chExt cx="6100657" cy="9478822"/>
          </a:xfrm>
        </p:grpSpPr>
        <p:sp>
          <p:nvSpPr>
            <p:cNvPr id="3" name="矩形 2"/>
            <p:cNvSpPr/>
            <p:nvPr/>
          </p:nvSpPr>
          <p:spPr>
            <a:xfrm>
              <a:off x="1804816" y="230048"/>
              <a:ext cx="1745767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dapter Trimming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1802417" y="680048"/>
              <a:ext cx="2592160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ength Distribution Confirmation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1802417" y="1214532"/>
              <a:ext cx="1422254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ad Collapse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1802418" y="2468511"/>
              <a:ext cx="2986694" cy="38567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ad Mapping to Genome with bowtie1</a:t>
              </a:r>
            </a:p>
          </p:txBody>
        </p:sp>
        <p:sp>
          <p:nvSpPr>
            <p:cNvPr id="61" name="矩形 60"/>
            <p:cNvSpPr/>
            <p:nvPr/>
          </p:nvSpPr>
          <p:spPr>
            <a:xfrm>
              <a:off x="1802420" y="1740994"/>
              <a:ext cx="2986692" cy="51719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move Reads generated from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RNA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loci or plastid genome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1802417" y="6083051"/>
              <a:ext cx="4169758" cy="64572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bundanc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rand bias filter: sense/total ≥ 0.9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bundance bias: (mature + star) / total ≥ 0.7</a:t>
              </a:r>
            </a:p>
          </p:txBody>
        </p:sp>
        <p:sp>
          <p:nvSpPr>
            <p:cNvPr id="73" name="矩形 72"/>
            <p:cNvSpPr/>
            <p:nvPr/>
          </p:nvSpPr>
          <p:spPr>
            <a:xfrm>
              <a:off x="1802418" y="6982248"/>
              <a:ext cx="4757210" cy="4711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last against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Rbase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, version 22</a:t>
              </a:r>
            </a:p>
            <a:p>
              <a:pPr marL="0" marR="0" lvl="2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≤ 4 nucleotide differences)</a:t>
              </a:r>
            </a:p>
          </p:txBody>
        </p:sp>
        <p:sp>
          <p:nvSpPr>
            <p:cNvPr id="74" name="矩形 73"/>
            <p:cNvSpPr/>
            <p:nvPr/>
          </p:nvSpPr>
          <p:spPr>
            <a:xfrm>
              <a:off x="1808029" y="7678713"/>
              <a:ext cx="235515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ound Matches in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Rbas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5" name="矩形 74"/>
            <p:cNvSpPr/>
            <p:nvPr/>
          </p:nvSpPr>
          <p:spPr>
            <a:xfrm>
              <a:off x="1799128" y="8748141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Known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6" name="矩形 75"/>
            <p:cNvSpPr/>
            <p:nvPr/>
          </p:nvSpPr>
          <p:spPr>
            <a:xfrm>
              <a:off x="3300405" y="8732529"/>
              <a:ext cx="862779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obabl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7" name="矩形 76"/>
            <p:cNvSpPr/>
            <p:nvPr/>
          </p:nvSpPr>
          <p:spPr>
            <a:xfrm>
              <a:off x="4431364" y="8732529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vel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8" name="矩形 77"/>
            <p:cNvSpPr/>
            <p:nvPr/>
          </p:nvSpPr>
          <p:spPr>
            <a:xfrm>
              <a:off x="5791745" y="8744223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ltered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7" name="直接箭头连接符 36"/>
            <p:cNvCxnSpPr>
              <a:stCxn id="74" idx="2"/>
              <a:endCxn id="75" idx="0"/>
            </p:cNvCxnSpPr>
            <p:nvPr/>
          </p:nvCxnSpPr>
          <p:spPr>
            <a:xfrm flipH="1">
              <a:off x="2176086" y="8058358"/>
              <a:ext cx="809521" cy="689783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/>
            <p:cNvCxnSpPr>
              <a:cxnSpLocks/>
              <a:stCxn id="74" idx="2"/>
              <a:endCxn id="76" idx="0"/>
            </p:cNvCxnSpPr>
            <p:nvPr/>
          </p:nvCxnSpPr>
          <p:spPr>
            <a:xfrm>
              <a:off x="2985607" y="8058358"/>
              <a:ext cx="746188" cy="67417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箭头连接符 79"/>
            <p:cNvCxnSpPr>
              <a:stCxn id="82" idx="2"/>
              <a:endCxn id="77" idx="0"/>
            </p:cNvCxnSpPr>
            <p:nvPr/>
          </p:nvCxnSpPr>
          <p:spPr>
            <a:xfrm flipH="1">
              <a:off x="4808322" y="8063698"/>
              <a:ext cx="668625" cy="66883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箭头连接符 80"/>
            <p:cNvCxnSpPr>
              <a:stCxn id="82" idx="2"/>
              <a:endCxn id="78" idx="0"/>
            </p:cNvCxnSpPr>
            <p:nvPr/>
          </p:nvCxnSpPr>
          <p:spPr>
            <a:xfrm>
              <a:off x="5476947" y="8063698"/>
              <a:ext cx="691756" cy="680525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矩形 81"/>
            <p:cNvSpPr/>
            <p:nvPr/>
          </p:nvSpPr>
          <p:spPr>
            <a:xfrm>
              <a:off x="4394265" y="7684053"/>
              <a:ext cx="2165363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 Matches in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Rbas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1" name="矩形 90"/>
            <p:cNvSpPr/>
            <p:nvPr/>
          </p:nvSpPr>
          <p:spPr>
            <a:xfrm>
              <a:off x="1808029" y="9329225"/>
              <a:ext cx="4775087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lter loci found in less than 2 library if number of Library ≥ 10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94" name="直接箭头连接符 93"/>
            <p:cNvCxnSpPr>
              <a:stCxn id="75" idx="2"/>
            </p:cNvCxnSpPr>
            <p:nvPr/>
          </p:nvCxnSpPr>
          <p:spPr>
            <a:xfrm>
              <a:off x="2176086" y="9127786"/>
              <a:ext cx="0" cy="20143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箭头连接符 94"/>
            <p:cNvCxnSpPr>
              <a:cxnSpLocks/>
              <a:stCxn id="76" idx="2"/>
            </p:cNvCxnSpPr>
            <p:nvPr/>
          </p:nvCxnSpPr>
          <p:spPr>
            <a:xfrm>
              <a:off x="3731795" y="9112174"/>
              <a:ext cx="54432" cy="21705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接箭头连接符 97"/>
            <p:cNvCxnSpPr>
              <a:stCxn id="77" idx="2"/>
            </p:cNvCxnSpPr>
            <p:nvPr/>
          </p:nvCxnSpPr>
          <p:spPr>
            <a:xfrm>
              <a:off x="4808322" y="9112174"/>
              <a:ext cx="0" cy="21705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矩形 24"/>
            <p:cNvSpPr/>
            <p:nvPr/>
          </p:nvSpPr>
          <p:spPr>
            <a:xfrm>
              <a:off x="1802417" y="3117455"/>
              <a:ext cx="3345764" cy="821271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ength of Mature miRNA: 20~22nt;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nimum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budance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of miRNA: ≥ 10;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enome Matches on Genome: ≤ 20</a:t>
              </a:r>
            </a:p>
          </p:txBody>
        </p:sp>
        <p:sp>
          <p:nvSpPr>
            <p:cNvPr id="26" name="矩形 25"/>
            <p:cNvSpPr/>
            <p:nvPr/>
          </p:nvSpPr>
          <p:spPr>
            <a:xfrm>
              <a:off x="1802417" y="4150496"/>
              <a:ext cx="3817333" cy="170765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ructur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nimal space size between miRNA and miRNA*: 5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space size between miRNA and miRNA*:300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mismatch in pairing region of miRNA duplex: 5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Mature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ulgeSize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: 4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mum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Size Different: 2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number of  asymmetry : 3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1010652" y="230048"/>
              <a:ext cx="791765" cy="262414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-processing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>
              <a:off x="1010652" y="3116624"/>
              <a:ext cx="791765" cy="361215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diction</a:t>
              </a:r>
              <a:endParaRPr kumimoji="0" lang="zh-CN" altLang="en-U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>
              <a:off x="1005679" y="6982248"/>
              <a:ext cx="793449" cy="2726622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nal-filtering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7" name="菱形 46"/>
            <p:cNvSpPr/>
            <p:nvPr/>
          </p:nvSpPr>
          <p:spPr>
            <a:xfrm>
              <a:off x="2476500" y="8166380"/>
              <a:ext cx="3648075" cy="453545"/>
            </a:xfrm>
            <a:prstGeom prst="diamond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ar expressed?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8" name="直接箭头连接符 67"/>
            <p:cNvCxnSpPr>
              <a:stCxn id="73" idx="2"/>
              <a:endCxn id="74" idx="0"/>
            </p:cNvCxnSpPr>
            <p:nvPr/>
          </p:nvCxnSpPr>
          <p:spPr>
            <a:xfrm flipH="1">
              <a:off x="2985607" y="7453354"/>
              <a:ext cx="1195416" cy="22535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箭头连接符 82"/>
            <p:cNvCxnSpPr>
              <a:stCxn id="73" idx="2"/>
              <a:endCxn id="82" idx="0"/>
            </p:cNvCxnSpPr>
            <p:nvPr/>
          </p:nvCxnSpPr>
          <p:spPr>
            <a:xfrm>
              <a:off x="4181023" y="7453354"/>
              <a:ext cx="1295924" cy="23069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 rot="16200000">
              <a:off x="-2318889" y="4789926"/>
              <a:ext cx="6125915" cy="52322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8100">
              <a:solidFill>
                <a:srgbClr val="7030A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2800" b="1" i="0" u="none" strike="noStrike" kern="1200" cap="none" spc="0" normalizeH="0" baseline="0" noProof="0" dirty="0">
                  <a:ln>
                    <a:noFill/>
                  </a:ln>
                  <a:solidFill>
                    <a:srgbClr val="7030A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orkflow for miRNA annotation</a:t>
              </a:r>
            </a:p>
          </p:txBody>
        </p:sp>
      </p:grpSp>
      <p:sp>
        <p:nvSpPr>
          <p:cNvPr id="5" name="文本框 4"/>
          <p:cNvSpPr txBox="1"/>
          <p:nvPr/>
        </p:nvSpPr>
        <p:spPr>
          <a:xfrm>
            <a:off x="1085646" y="9469962"/>
            <a:ext cx="481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. Workflow of miRNA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7156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10245" y="7063537"/>
            <a:ext cx="6547755" cy="253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. Conserved miRNAs overlapped  between sRNAanno and miRbase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served miRNAs of 45 plants were compared between sRNAanno and miRbase. All species are ordered according to the phylogenetic relationship of APG IV. Each cell represents whether a miRNA family (column) is annotated in a species (row) or not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077" y="422007"/>
            <a:ext cx="6108700" cy="6497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9529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940" y="430363"/>
            <a:ext cx="4770120" cy="3167449"/>
          </a:xfrm>
          <a:prstGeom prst="rect">
            <a:avLst/>
          </a:prstGeom>
        </p:spPr>
      </p:pic>
      <p:sp>
        <p:nvSpPr>
          <p:cNvPr id="3" name="文本框 4"/>
          <p:cNvSpPr txBox="1"/>
          <p:nvPr/>
        </p:nvSpPr>
        <p:spPr>
          <a:xfrm>
            <a:off x="155122" y="3745440"/>
            <a:ext cx="6547755" cy="1287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. Comparison of miRNA annotation results of rice from miRbase,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hortStack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, sRNAanno and miRDeep-P2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7594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746093" y="693692"/>
            <a:ext cx="1745767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dapter Trimming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1743694" y="1143692"/>
            <a:ext cx="2592160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ength Distribution Confirmatio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1743694" y="1678176"/>
            <a:ext cx="1422254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Collaps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743695" y="2932155"/>
            <a:ext cx="2986694" cy="385677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Mapping to Genome with bowtie1</a:t>
            </a:r>
          </a:p>
        </p:txBody>
      </p:sp>
      <p:sp>
        <p:nvSpPr>
          <p:cNvPr id="61" name="矩形 60"/>
          <p:cNvSpPr/>
          <p:nvPr/>
        </p:nvSpPr>
        <p:spPr>
          <a:xfrm>
            <a:off x="1743697" y="2204638"/>
            <a:ext cx="2986692" cy="517194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Reads generated from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RN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oci or plastid genom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1743693" y="5691037"/>
            <a:ext cx="4928675" cy="471106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max region phase score: 15</a:t>
            </a:r>
          </a:p>
        </p:txBody>
      </p:sp>
      <p:sp>
        <p:nvSpPr>
          <p:cNvPr id="74" name="矩形 73"/>
          <p:cNvSpPr/>
          <p:nvPr/>
        </p:nvSpPr>
        <p:spPr>
          <a:xfrm>
            <a:off x="1749305" y="6532282"/>
            <a:ext cx="2355155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AS</a:t>
            </a:r>
            <a:endParaRPr kumimoji="0" lang="en-US" altLang="zh-CN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3868208" y="7286825"/>
            <a:ext cx="2804160" cy="40481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aximum Mean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mer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frequency: ≤ 5 </a:t>
            </a:r>
          </a:p>
        </p:txBody>
      </p:sp>
      <p:cxnSp>
        <p:nvCxnSpPr>
          <p:cNvPr id="37" name="直接箭头连接符 36"/>
          <p:cNvCxnSpPr>
            <a:stCxn id="74" idx="2"/>
          </p:cNvCxnSpPr>
          <p:nvPr/>
        </p:nvCxnSpPr>
        <p:spPr>
          <a:xfrm flipH="1">
            <a:off x="2926882" y="6911927"/>
            <a:ext cx="1" cy="1126087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箭头连接符 79"/>
          <p:cNvCxnSpPr>
            <a:stCxn id="82" idx="2"/>
          </p:cNvCxnSpPr>
          <p:nvPr/>
        </p:nvCxnSpPr>
        <p:spPr>
          <a:xfrm>
            <a:off x="5589687" y="6908949"/>
            <a:ext cx="0" cy="399242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矩形 81"/>
          <p:cNvSpPr/>
          <p:nvPr/>
        </p:nvSpPr>
        <p:spPr>
          <a:xfrm>
            <a:off x="4507005" y="6529304"/>
            <a:ext cx="2165363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AS</a:t>
            </a:r>
            <a:endParaRPr kumimoji="0" lang="en-US" altLang="zh-CN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1749305" y="8038014"/>
            <a:ext cx="4923063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lter loci found in less than 2 library if number of Library ≥ 10</a:t>
            </a:r>
            <a:endParaRPr kumimoji="0" lang="en-US" altLang="zh-CN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98" name="直接箭头连接符 97"/>
          <p:cNvCxnSpPr/>
          <p:nvPr/>
        </p:nvCxnSpPr>
        <p:spPr>
          <a:xfrm>
            <a:off x="5418222" y="7690431"/>
            <a:ext cx="0" cy="347583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矩形 24"/>
          <p:cNvSpPr/>
          <p:nvPr/>
        </p:nvSpPr>
        <p:spPr>
          <a:xfrm>
            <a:off x="1743694" y="3581099"/>
            <a:ext cx="3345764" cy="821271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ocusLen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: 100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st abundance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iRN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ength: 2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or 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endParaRPr kumimoji="0" lang="en-US" altLang="zh-CN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1743694" y="4665637"/>
            <a:ext cx="3817333" cy="796520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hase pattern-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aximum p-value: 1e-10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phase ratio: 0.3</a:t>
            </a:r>
          </a:p>
        </p:txBody>
      </p:sp>
      <p:sp>
        <p:nvSpPr>
          <p:cNvPr id="4" name="矩形 3"/>
          <p:cNvSpPr/>
          <p:nvPr/>
        </p:nvSpPr>
        <p:spPr>
          <a:xfrm>
            <a:off x="1079499" y="693692"/>
            <a:ext cx="664195" cy="2624140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process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079500" y="3580268"/>
            <a:ext cx="664194" cy="1881889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diction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077641" y="5691037"/>
            <a:ext cx="662763" cy="2726622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nal-filter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68" name="直接箭头连接符 67"/>
          <p:cNvCxnSpPr>
            <a:stCxn id="73" idx="2"/>
            <a:endCxn id="74" idx="0"/>
          </p:cNvCxnSpPr>
          <p:nvPr/>
        </p:nvCxnSpPr>
        <p:spPr>
          <a:xfrm flipH="1">
            <a:off x="2926883" y="6162143"/>
            <a:ext cx="1281148" cy="370139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/>
          <p:cNvCxnSpPr>
            <a:stCxn id="73" idx="2"/>
            <a:endCxn id="82" idx="0"/>
          </p:cNvCxnSpPr>
          <p:nvPr/>
        </p:nvCxnSpPr>
        <p:spPr>
          <a:xfrm>
            <a:off x="4208031" y="6162143"/>
            <a:ext cx="1381656" cy="367161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矩形 22">
            <a:extLst>
              <a:ext uri="{FF2B5EF4-FFF2-40B4-BE49-F238E27FC236}">
                <a16:creationId xmlns:a16="http://schemas.microsoft.com/office/drawing/2014/main" id="{9DE07CF7-A7A7-4857-9025-139C62AD2BEB}"/>
              </a:ext>
            </a:extLst>
          </p:cNvPr>
          <p:cNvSpPr/>
          <p:nvPr/>
        </p:nvSpPr>
        <p:spPr>
          <a:xfrm>
            <a:off x="417975" y="2105662"/>
            <a:ext cx="664194" cy="5119950"/>
          </a:xfrm>
          <a:prstGeom prst="rect">
            <a:avLst/>
          </a:prstGeom>
          <a:solidFill>
            <a:srgbClr val="00B0F0"/>
          </a:solidFill>
          <a:ln w="381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orkflow for PHAS analysis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srgbClr val="7030A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116818" y="8764033"/>
            <a:ext cx="4694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4. Workflow of PHAS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4441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467987" y="1366860"/>
            <a:ext cx="1745767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dapter Trimming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2465588" y="1816860"/>
            <a:ext cx="2592160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ength Distribution Confirmatio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2465588" y="2351344"/>
            <a:ext cx="1422254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Collaps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2465589" y="3605323"/>
            <a:ext cx="2986694" cy="385677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Mapping to Genome with bowtie1</a:t>
            </a:r>
          </a:p>
        </p:txBody>
      </p:sp>
      <p:sp>
        <p:nvSpPr>
          <p:cNvPr id="61" name="矩形 60"/>
          <p:cNvSpPr/>
          <p:nvPr/>
        </p:nvSpPr>
        <p:spPr>
          <a:xfrm>
            <a:off x="2465591" y="2877806"/>
            <a:ext cx="2986692" cy="517194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Reads generated from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RN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loci or plastid genom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2462299" y="5590550"/>
            <a:ext cx="3645327" cy="1322221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loci overlapping with 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ona fine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AS loci</a:t>
            </a:r>
          </a:p>
        </p:txBody>
      </p:sp>
      <p:sp>
        <p:nvSpPr>
          <p:cNvPr id="25" name="矩形 24"/>
          <p:cNvSpPr/>
          <p:nvPr/>
        </p:nvSpPr>
        <p:spPr>
          <a:xfrm>
            <a:off x="2465588" y="4254267"/>
            <a:ext cx="3345764" cy="1058956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bundance of 23/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iRN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/ total abundance ≥ 0.5</a:t>
            </a:r>
          </a:p>
        </p:txBody>
      </p:sp>
      <p:sp>
        <p:nvSpPr>
          <p:cNvPr id="4" name="矩形 3"/>
          <p:cNvSpPr/>
          <p:nvPr/>
        </p:nvSpPr>
        <p:spPr>
          <a:xfrm>
            <a:off x="1744579" y="1366860"/>
            <a:ext cx="721010" cy="2624140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process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744578" y="4253437"/>
            <a:ext cx="721010" cy="1059786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diction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742843" y="5590552"/>
            <a:ext cx="719456" cy="1322222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nal-filter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A0E47B6-02FE-4C0B-A910-E2ED561C7E95}"/>
              </a:ext>
            </a:extLst>
          </p:cNvPr>
          <p:cNvSpPr/>
          <p:nvPr/>
        </p:nvSpPr>
        <p:spPr>
          <a:xfrm>
            <a:off x="803276" y="2087662"/>
            <a:ext cx="925137" cy="4331550"/>
          </a:xfrm>
          <a:prstGeom prst="rect">
            <a:avLst/>
          </a:prstGeom>
          <a:solidFill>
            <a:srgbClr val="FFC000"/>
          </a:solidFill>
          <a:ln w="381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lvl="0" algn="ctr" defTabSz="914400"/>
            <a:r>
              <a:rPr lang="en-US" altLang="zh-CN" sz="2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rkflow for </a:t>
            </a:r>
            <a:r>
              <a:rPr lang="en-US" altLang="zh-CN" sz="28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US" altLang="zh-CN" sz="2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siRNA loci annotation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srgbClr val="7030A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803276" y="7343993"/>
            <a:ext cx="554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5. Workflow of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hc-siRNA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loci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3349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10788" y="7814256"/>
            <a:ext cx="58494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6. Overview of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siRNA loci of each species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nnotated in sRNAanno.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88" y="1528997"/>
            <a:ext cx="6118486" cy="6118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6489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</TotalTime>
  <Words>423</Words>
  <Application>Microsoft Office PowerPoint</Application>
  <PresentationFormat>A4 纸张(210x297 毫米)</PresentationFormat>
  <Paragraphs>72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ui Xia</dc:creator>
  <cp:lastModifiedBy>Chen CJ</cp:lastModifiedBy>
  <cp:revision>44</cp:revision>
  <dcterms:created xsi:type="dcterms:W3CDTF">2019-08-09T12:33:53Z</dcterms:created>
  <dcterms:modified xsi:type="dcterms:W3CDTF">2020-06-17T08:35:59Z</dcterms:modified>
</cp:coreProperties>
</file>